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4"/>
  </p:notesMasterIdLst>
  <p:sldIdLst>
    <p:sldId id="256" r:id="rId2"/>
    <p:sldId id="314" r:id="rId3"/>
  </p:sldIdLst>
  <p:sldSz cx="5303838" cy="84582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717"/>
  </p:normalViewPr>
  <p:slideViewPr>
    <p:cSldViewPr snapToGrid="0">
      <p:cViewPr varScale="1">
        <p:scale>
          <a:sx n="82" d="100"/>
          <a:sy n="82" d="100"/>
        </p:scale>
        <p:origin x="3456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2851979-8189-0D43-BEC0-F02A564C5839}" type="datetimeFigureOut">
              <a:rPr lang="en-US" smtClean="0"/>
              <a:t>7/11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460625" y="1143000"/>
            <a:ext cx="19367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FDC6791-A447-A944-8861-B1C7F58D1C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92987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397788" y="1384248"/>
            <a:ext cx="4508262" cy="2944707"/>
          </a:xfrm>
        </p:spPr>
        <p:txBody>
          <a:bodyPr anchor="b"/>
          <a:lstStyle>
            <a:lvl1pPr algn="ctr">
              <a:defRPr sz="348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662980" y="4442514"/>
            <a:ext cx="3977879" cy="2042106"/>
          </a:xfrm>
        </p:spPr>
        <p:txBody>
          <a:bodyPr/>
          <a:lstStyle>
            <a:lvl1pPr marL="0" indent="0" algn="ctr">
              <a:buNone/>
              <a:defRPr sz="1392"/>
            </a:lvl1pPr>
            <a:lvl2pPr marL="265176" indent="0" algn="ctr">
              <a:buNone/>
              <a:defRPr sz="1160"/>
            </a:lvl2pPr>
            <a:lvl3pPr marL="530352" indent="0" algn="ctr">
              <a:buNone/>
              <a:defRPr sz="1044"/>
            </a:lvl3pPr>
            <a:lvl4pPr marL="795528" indent="0" algn="ctr">
              <a:buNone/>
              <a:defRPr sz="928"/>
            </a:lvl4pPr>
            <a:lvl5pPr marL="1060704" indent="0" algn="ctr">
              <a:buNone/>
              <a:defRPr sz="928"/>
            </a:lvl5pPr>
            <a:lvl6pPr marL="1325880" indent="0" algn="ctr">
              <a:buNone/>
              <a:defRPr sz="928"/>
            </a:lvl6pPr>
            <a:lvl7pPr marL="1591056" indent="0" algn="ctr">
              <a:buNone/>
              <a:defRPr sz="928"/>
            </a:lvl7pPr>
            <a:lvl8pPr marL="1856232" indent="0" algn="ctr">
              <a:buNone/>
              <a:defRPr sz="928"/>
            </a:lvl8pPr>
            <a:lvl9pPr marL="2121408" indent="0" algn="ctr">
              <a:buNone/>
              <a:defRPr sz="928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65E7A7-1143-A44B-A95E-0BEF3B41927D}" type="datetimeFigureOut">
              <a:rPr lang="en-US" smtClean="0"/>
              <a:t>7/1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8F8CDA-C0B5-7E41-A8C7-A35C49EA6F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74856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65E7A7-1143-A44B-A95E-0BEF3B41927D}" type="datetimeFigureOut">
              <a:rPr lang="en-US" smtClean="0"/>
              <a:t>7/1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8F8CDA-C0B5-7E41-A8C7-A35C49EA6F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3064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95559" y="450321"/>
            <a:ext cx="1143640" cy="7167934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64639" y="450321"/>
            <a:ext cx="3364622" cy="7167934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65E7A7-1143-A44B-A95E-0BEF3B41927D}" type="datetimeFigureOut">
              <a:rPr lang="en-US" smtClean="0"/>
              <a:t>7/1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8F8CDA-C0B5-7E41-A8C7-A35C49EA6F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78465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65E7A7-1143-A44B-A95E-0BEF3B41927D}" type="datetimeFigureOut">
              <a:rPr lang="en-US" smtClean="0"/>
              <a:t>7/1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8F8CDA-C0B5-7E41-A8C7-A35C49EA6F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26238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61877" y="2108679"/>
            <a:ext cx="4574560" cy="3518376"/>
          </a:xfrm>
        </p:spPr>
        <p:txBody>
          <a:bodyPr anchor="b"/>
          <a:lstStyle>
            <a:lvl1pPr>
              <a:defRPr sz="348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61877" y="5660339"/>
            <a:ext cx="4574560" cy="1850231"/>
          </a:xfrm>
        </p:spPr>
        <p:txBody>
          <a:bodyPr/>
          <a:lstStyle>
            <a:lvl1pPr marL="0" indent="0">
              <a:buNone/>
              <a:defRPr sz="1392">
                <a:solidFill>
                  <a:schemeClr val="tx1">
                    <a:tint val="82000"/>
                  </a:schemeClr>
                </a:solidFill>
              </a:defRPr>
            </a:lvl1pPr>
            <a:lvl2pPr marL="265176" indent="0">
              <a:buNone/>
              <a:defRPr sz="1160">
                <a:solidFill>
                  <a:schemeClr val="tx1">
                    <a:tint val="82000"/>
                  </a:schemeClr>
                </a:solidFill>
              </a:defRPr>
            </a:lvl2pPr>
            <a:lvl3pPr marL="530352" indent="0">
              <a:buNone/>
              <a:defRPr sz="1044">
                <a:solidFill>
                  <a:schemeClr val="tx1">
                    <a:tint val="82000"/>
                  </a:schemeClr>
                </a:solidFill>
              </a:defRPr>
            </a:lvl3pPr>
            <a:lvl4pPr marL="795528" indent="0">
              <a:buNone/>
              <a:defRPr sz="928">
                <a:solidFill>
                  <a:schemeClr val="tx1">
                    <a:tint val="82000"/>
                  </a:schemeClr>
                </a:solidFill>
              </a:defRPr>
            </a:lvl4pPr>
            <a:lvl5pPr marL="1060704" indent="0">
              <a:buNone/>
              <a:defRPr sz="928">
                <a:solidFill>
                  <a:schemeClr val="tx1">
                    <a:tint val="82000"/>
                  </a:schemeClr>
                </a:solidFill>
              </a:defRPr>
            </a:lvl5pPr>
            <a:lvl6pPr marL="1325880" indent="0">
              <a:buNone/>
              <a:defRPr sz="928">
                <a:solidFill>
                  <a:schemeClr val="tx1">
                    <a:tint val="82000"/>
                  </a:schemeClr>
                </a:solidFill>
              </a:defRPr>
            </a:lvl6pPr>
            <a:lvl7pPr marL="1591056" indent="0">
              <a:buNone/>
              <a:defRPr sz="928">
                <a:solidFill>
                  <a:schemeClr val="tx1">
                    <a:tint val="82000"/>
                  </a:schemeClr>
                </a:solidFill>
              </a:defRPr>
            </a:lvl7pPr>
            <a:lvl8pPr marL="1856232" indent="0">
              <a:buNone/>
              <a:defRPr sz="928">
                <a:solidFill>
                  <a:schemeClr val="tx1">
                    <a:tint val="82000"/>
                  </a:schemeClr>
                </a:solidFill>
              </a:defRPr>
            </a:lvl8pPr>
            <a:lvl9pPr marL="2121408" indent="0">
              <a:buNone/>
              <a:defRPr sz="928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65E7A7-1143-A44B-A95E-0BEF3B41927D}" type="datetimeFigureOut">
              <a:rPr lang="en-US" smtClean="0"/>
              <a:t>7/1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8F8CDA-C0B5-7E41-A8C7-A35C49EA6F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59753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64639" y="2251604"/>
            <a:ext cx="2254131" cy="536665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85068" y="2251604"/>
            <a:ext cx="2254131" cy="536665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65E7A7-1143-A44B-A95E-0BEF3B41927D}" type="datetimeFigureOut">
              <a:rPr lang="en-US" smtClean="0"/>
              <a:t>7/11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8F8CDA-C0B5-7E41-A8C7-A35C49EA6F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43737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65330" y="450323"/>
            <a:ext cx="4574560" cy="1634861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65330" y="2073434"/>
            <a:ext cx="2243772" cy="1016158"/>
          </a:xfrm>
        </p:spPr>
        <p:txBody>
          <a:bodyPr anchor="b"/>
          <a:lstStyle>
            <a:lvl1pPr marL="0" indent="0">
              <a:buNone/>
              <a:defRPr sz="1392" b="1"/>
            </a:lvl1pPr>
            <a:lvl2pPr marL="265176" indent="0">
              <a:buNone/>
              <a:defRPr sz="1160" b="1"/>
            </a:lvl2pPr>
            <a:lvl3pPr marL="530352" indent="0">
              <a:buNone/>
              <a:defRPr sz="1044" b="1"/>
            </a:lvl3pPr>
            <a:lvl4pPr marL="795528" indent="0">
              <a:buNone/>
              <a:defRPr sz="928" b="1"/>
            </a:lvl4pPr>
            <a:lvl5pPr marL="1060704" indent="0">
              <a:buNone/>
              <a:defRPr sz="928" b="1"/>
            </a:lvl5pPr>
            <a:lvl6pPr marL="1325880" indent="0">
              <a:buNone/>
              <a:defRPr sz="928" b="1"/>
            </a:lvl6pPr>
            <a:lvl7pPr marL="1591056" indent="0">
              <a:buNone/>
              <a:defRPr sz="928" b="1"/>
            </a:lvl7pPr>
            <a:lvl8pPr marL="1856232" indent="0">
              <a:buNone/>
              <a:defRPr sz="928" b="1"/>
            </a:lvl8pPr>
            <a:lvl9pPr marL="2121408" indent="0">
              <a:buNone/>
              <a:defRPr sz="928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65330" y="3089593"/>
            <a:ext cx="2243772" cy="454432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2685068" y="2073434"/>
            <a:ext cx="2254822" cy="1016158"/>
          </a:xfrm>
        </p:spPr>
        <p:txBody>
          <a:bodyPr anchor="b"/>
          <a:lstStyle>
            <a:lvl1pPr marL="0" indent="0">
              <a:buNone/>
              <a:defRPr sz="1392" b="1"/>
            </a:lvl1pPr>
            <a:lvl2pPr marL="265176" indent="0">
              <a:buNone/>
              <a:defRPr sz="1160" b="1"/>
            </a:lvl2pPr>
            <a:lvl3pPr marL="530352" indent="0">
              <a:buNone/>
              <a:defRPr sz="1044" b="1"/>
            </a:lvl3pPr>
            <a:lvl4pPr marL="795528" indent="0">
              <a:buNone/>
              <a:defRPr sz="928" b="1"/>
            </a:lvl4pPr>
            <a:lvl5pPr marL="1060704" indent="0">
              <a:buNone/>
              <a:defRPr sz="928" b="1"/>
            </a:lvl5pPr>
            <a:lvl6pPr marL="1325880" indent="0">
              <a:buNone/>
              <a:defRPr sz="928" b="1"/>
            </a:lvl6pPr>
            <a:lvl7pPr marL="1591056" indent="0">
              <a:buNone/>
              <a:defRPr sz="928" b="1"/>
            </a:lvl7pPr>
            <a:lvl8pPr marL="1856232" indent="0">
              <a:buNone/>
              <a:defRPr sz="928" b="1"/>
            </a:lvl8pPr>
            <a:lvl9pPr marL="2121408" indent="0">
              <a:buNone/>
              <a:defRPr sz="928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2685068" y="3089593"/>
            <a:ext cx="2254822" cy="454432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65E7A7-1143-A44B-A95E-0BEF3B41927D}" type="datetimeFigureOut">
              <a:rPr lang="en-US" smtClean="0"/>
              <a:t>7/11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8F8CDA-C0B5-7E41-A8C7-A35C49EA6F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1949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65E7A7-1143-A44B-A95E-0BEF3B41927D}" type="datetimeFigureOut">
              <a:rPr lang="en-US" smtClean="0"/>
              <a:t>7/11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8F8CDA-C0B5-7E41-A8C7-A35C49EA6F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4825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65E7A7-1143-A44B-A95E-0BEF3B41927D}" type="datetimeFigureOut">
              <a:rPr lang="en-US" smtClean="0"/>
              <a:t>7/11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8F8CDA-C0B5-7E41-A8C7-A35C49EA6F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9219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65330" y="563880"/>
            <a:ext cx="1710626" cy="1973580"/>
          </a:xfrm>
        </p:spPr>
        <p:txBody>
          <a:bodyPr anchor="b"/>
          <a:lstStyle>
            <a:lvl1pPr>
              <a:defRPr sz="1856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254822" y="1217826"/>
            <a:ext cx="2685068" cy="6010804"/>
          </a:xfrm>
        </p:spPr>
        <p:txBody>
          <a:bodyPr/>
          <a:lstStyle>
            <a:lvl1pPr>
              <a:defRPr sz="1856"/>
            </a:lvl1pPr>
            <a:lvl2pPr>
              <a:defRPr sz="1624"/>
            </a:lvl2pPr>
            <a:lvl3pPr>
              <a:defRPr sz="1392"/>
            </a:lvl3pPr>
            <a:lvl4pPr>
              <a:defRPr sz="1160"/>
            </a:lvl4pPr>
            <a:lvl5pPr>
              <a:defRPr sz="1160"/>
            </a:lvl5pPr>
            <a:lvl6pPr>
              <a:defRPr sz="1160"/>
            </a:lvl6pPr>
            <a:lvl7pPr>
              <a:defRPr sz="1160"/>
            </a:lvl7pPr>
            <a:lvl8pPr>
              <a:defRPr sz="1160"/>
            </a:lvl8pPr>
            <a:lvl9pPr>
              <a:defRPr sz="116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65330" y="2537460"/>
            <a:ext cx="1710626" cy="4700959"/>
          </a:xfrm>
        </p:spPr>
        <p:txBody>
          <a:bodyPr/>
          <a:lstStyle>
            <a:lvl1pPr marL="0" indent="0">
              <a:buNone/>
              <a:defRPr sz="928"/>
            </a:lvl1pPr>
            <a:lvl2pPr marL="265176" indent="0">
              <a:buNone/>
              <a:defRPr sz="812"/>
            </a:lvl2pPr>
            <a:lvl3pPr marL="530352" indent="0">
              <a:buNone/>
              <a:defRPr sz="696"/>
            </a:lvl3pPr>
            <a:lvl4pPr marL="795528" indent="0">
              <a:buNone/>
              <a:defRPr sz="580"/>
            </a:lvl4pPr>
            <a:lvl5pPr marL="1060704" indent="0">
              <a:buNone/>
              <a:defRPr sz="580"/>
            </a:lvl5pPr>
            <a:lvl6pPr marL="1325880" indent="0">
              <a:buNone/>
              <a:defRPr sz="580"/>
            </a:lvl6pPr>
            <a:lvl7pPr marL="1591056" indent="0">
              <a:buNone/>
              <a:defRPr sz="580"/>
            </a:lvl7pPr>
            <a:lvl8pPr marL="1856232" indent="0">
              <a:buNone/>
              <a:defRPr sz="580"/>
            </a:lvl8pPr>
            <a:lvl9pPr marL="2121408" indent="0">
              <a:buNone/>
              <a:defRPr sz="58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65E7A7-1143-A44B-A95E-0BEF3B41927D}" type="datetimeFigureOut">
              <a:rPr lang="en-US" smtClean="0"/>
              <a:t>7/11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8F8CDA-C0B5-7E41-A8C7-A35C49EA6F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53030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65330" y="563880"/>
            <a:ext cx="1710626" cy="1973580"/>
          </a:xfrm>
        </p:spPr>
        <p:txBody>
          <a:bodyPr anchor="b"/>
          <a:lstStyle>
            <a:lvl1pPr>
              <a:defRPr sz="1856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254822" y="1217826"/>
            <a:ext cx="2685068" cy="6010804"/>
          </a:xfrm>
        </p:spPr>
        <p:txBody>
          <a:bodyPr anchor="t"/>
          <a:lstStyle>
            <a:lvl1pPr marL="0" indent="0">
              <a:buNone/>
              <a:defRPr sz="1856"/>
            </a:lvl1pPr>
            <a:lvl2pPr marL="265176" indent="0">
              <a:buNone/>
              <a:defRPr sz="1624"/>
            </a:lvl2pPr>
            <a:lvl3pPr marL="530352" indent="0">
              <a:buNone/>
              <a:defRPr sz="1392"/>
            </a:lvl3pPr>
            <a:lvl4pPr marL="795528" indent="0">
              <a:buNone/>
              <a:defRPr sz="1160"/>
            </a:lvl4pPr>
            <a:lvl5pPr marL="1060704" indent="0">
              <a:buNone/>
              <a:defRPr sz="1160"/>
            </a:lvl5pPr>
            <a:lvl6pPr marL="1325880" indent="0">
              <a:buNone/>
              <a:defRPr sz="1160"/>
            </a:lvl6pPr>
            <a:lvl7pPr marL="1591056" indent="0">
              <a:buNone/>
              <a:defRPr sz="1160"/>
            </a:lvl7pPr>
            <a:lvl8pPr marL="1856232" indent="0">
              <a:buNone/>
              <a:defRPr sz="1160"/>
            </a:lvl8pPr>
            <a:lvl9pPr marL="2121408" indent="0">
              <a:buNone/>
              <a:defRPr sz="116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65330" y="2537460"/>
            <a:ext cx="1710626" cy="4700959"/>
          </a:xfrm>
        </p:spPr>
        <p:txBody>
          <a:bodyPr/>
          <a:lstStyle>
            <a:lvl1pPr marL="0" indent="0">
              <a:buNone/>
              <a:defRPr sz="928"/>
            </a:lvl1pPr>
            <a:lvl2pPr marL="265176" indent="0">
              <a:buNone/>
              <a:defRPr sz="812"/>
            </a:lvl2pPr>
            <a:lvl3pPr marL="530352" indent="0">
              <a:buNone/>
              <a:defRPr sz="696"/>
            </a:lvl3pPr>
            <a:lvl4pPr marL="795528" indent="0">
              <a:buNone/>
              <a:defRPr sz="580"/>
            </a:lvl4pPr>
            <a:lvl5pPr marL="1060704" indent="0">
              <a:buNone/>
              <a:defRPr sz="580"/>
            </a:lvl5pPr>
            <a:lvl6pPr marL="1325880" indent="0">
              <a:buNone/>
              <a:defRPr sz="580"/>
            </a:lvl6pPr>
            <a:lvl7pPr marL="1591056" indent="0">
              <a:buNone/>
              <a:defRPr sz="580"/>
            </a:lvl7pPr>
            <a:lvl8pPr marL="1856232" indent="0">
              <a:buNone/>
              <a:defRPr sz="580"/>
            </a:lvl8pPr>
            <a:lvl9pPr marL="2121408" indent="0">
              <a:buNone/>
              <a:defRPr sz="58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65E7A7-1143-A44B-A95E-0BEF3B41927D}" type="datetimeFigureOut">
              <a:rPr lang="en-US" smtClean="0"/>
              <a:t>7/11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8F8CDA-C0B5-7E41-A8C7-A35C49EA6F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27325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64639" y="450323"/>
            <a:ext cx="4574560" cy="163486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64639" y="2251604"/>
            <a:ext cx="4574560" cy="536665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64639" y="7839500"/>
            <a:ext cx="1193364" cy="45032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96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F65E7A7-1143-A44B-A95E-0BEF3B41927D}" type="datetimeFigureOut">
              <a:rPr lang="en-US" smtClean="0"/>
              <a:t>7/1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756897" y="7839500"/>
            <a:ext cx="1790045" cy="45032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96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3745835" y="7839500"/>
            <a:ext cx="1193364" cy="45032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96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88F8CDA-C0B5-7E41-A8C7-A35C49EA6F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69875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530352" rtl="0" eaLnBrk="1" latinLnBrk="0" hangingPunct="1">
        <a:lnSpc>
          <a:spcPct val="90000"/>
        </a:lnSpc>
        <a:spcBef>
          <a:spcPct val="0"/>
        </a:spcBef>
        <a:buNone/>
        <a:defRPr sz="255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32588" indent="-132588" algn="l" defTabSz="530352" rtl="0" eaLnBrk="1" latinLnBrk="0" hangingPunct="1">
        <a:lnSpc>
          <a:spcPct val="90000"/>
        </a:lnSpc>
        <a:spcBef>
          <a:spcPts val="580"/>
        </a:spcBef>
        <a:buFont typeface="Arial" panose="020B0604020202020204" pitchFamily="34" charset="0"/>
        <a:buChar char="•"/>
        <a:defRPr sz="1624" kern="1200">
          <a:solidFill>
            <a:schemeClr val="tx1"/>
          </a:solidFill>
          <a:latin typeface="+mn-lt"/>
          <a:ea typeface="+mn-ea"/>
          <a:cs typeface="+mn-cs"/>
        </a:defRPr>
      </a:lvl1pPr>
      <a:lvl2pPr marL="397764" indent="-132588" algn="l" defTabSz="530352" rtl="0" eaLnBrk="1" latinLnBrk="0" hangingPunct="1">
        <a:lnSpc>
          <a:spcPct val="90000"/>
        </a:lnSpc>
        <a:spcBef>
          <a:spcPts val="290"/>
        </a:spcBef>
        <a:buFont typeface="Arial" panose="020B0604020202020204" pitchFamily="34" charset="0"/>
        <a:buChar char="•"/>
        <a:defRPr sz="1392" kern="1200">
          <a:solidFill>
            <a:schemeClr val="tx1"/>
          </a:solidFill>
          <a:latin typeface="+mn-lt"/>
          <a:ea typeface="+mn-ea"/>
          <a:cs typeface="+mn-cs"/>
        </a:defRPr>
      </a:lvl2pPr>
      <a:lvl3pPr marL="662940" indent="-132588" algn="l" defTabSz="530352" rtl="0" eaLnBrk="1" latinLnBrk="0" hangingPunct="1">
        <a:lnSpc>
          <a:spcPct val="90000"/>
        </a:lnSpc>
        <a:spcBef>
          <a:spcPts val="290"/>
        </a:spcBef>
        <a:buFont typeface="Arial" panose="020B0604020202020204" pitchFamily="34" charset="0"/>
        <a:buChar char="•"/>
        <a:defRPr sz="1160" kern="1200">
          <a:solidFill>
            <a:schemeClr val="tx1"/>
          </a:solidFill>
          <a:latin typeface="+mn-lt"/>
          <a:ea typeface="+mn-ea"/>
          <a:cs typeface="+mn-cs"/>
        </a:defRPr>
      </a:lvl3pPr>
      <a:lvl4pPr marL="928116" indent="-132588" algn="l" defTabSz="530352" rtl="0" eaLnBrk="1" latinLnBrk="0" hangingPunct="1">
        <a:lnSpc>
          <a:spcPct val="90000"/>
        </a:lnSpc>
        <a:spcBef>
          <a:spcPts val="290"/>
        </a:spcBef>
        <a:buFont typeface="Arial" panose="020B0604020202020204" pitchFamily="34" charset="0"/>
        <a:buChar char="•"/>
        <a:defRPr sz="1044" kern="1200">
          <a:solidFill>
            <a:schemeClr val="tx1"/>
          </a:solidFill>
          <a:latin typeface="+mn-lt"/>
          <a:ea typeface="+mn-ea"/>
          <a:cs typeface="+mn-cs"/>
        </a:defRPr>
      </a:lvl4pPr>
      <a:lvl5pPr marL="1193292" indent="-132588" algn="l" defTabSz="530352" rtl="0" eaLnBrk="1" latinLnBrk="0" hangingPunct="1">
        <a:lnSpc>
          <a:spcPct val="90000"/>
        </a:lnSpc>
        <a:spcBef>
          <a:spcPts val="290"/>
        </a:spcBef>
        <a:buFont typeface="Arial" panose="020B0604020202020204" pitchFamily="34" charset="0"/>
        <a:buChar char="•"/>
        <a:defRPr sz="1044" kern="1200">
          <a:solidFill>
            <a:schemeClr val="tx1"/>
          </a:solidFill>
          <a:latin typeface="+mn-lt"/>
          <a:ea typeface="+mn-ea"/>
          <a:cs typeface="+mn-cs"/>
        </a:defRPr>
      </a:lvl5pPr>
      <a:lvl6pPr marL="1458468" indent="-132588" algn="l" defTabSz="530352" rtl="0" eaLnBrk="1" latinLnBrk="0" hangingPunct="1">
        <a:lnSpc>
          <a:spcPct val="90000"/>
        </a:lnSpc>
        <a:spcBef>
          <a:spcPts val="290"/>
        </a:spcBef>
        <a:buFont typeface="Arial" panose="020B0604020202020204" pitchFamily="34" charset="0"/>
        <a:buChar char="•"/>
        <a:defRPr sz="1044" kern="1200">
          <a:solidFill>
            <a:schemeClr val="tx1"/>
          </a:solidFill>
          <a:latin typeface="+mn-lt"/>
          <a:ea typeface="+mn-ea"/>
          <a:cs typeface="+mn-cs"/>
        </a:defRPr>
      </a:lvl6pPr>
      <a:lvl7pPr marL="1723644" indent="-132588" algn="l" defTabSz="530352" rtl="0" eaLnBrk="1" latinLnBrk="0" hangingPunct="1">
        <a:lnSpc>
          <a:spcPct val="90000"/>
        </a:lnSpc>
        <a:spcBef>
          <a:spcPts val="290"/>
        </a:spcBef>
        <a:buFont typeface="Arial" panose="020B0604020202020204" pitchFamily="34" charset="0"/>
        <a:buChar char="•"/>
        <a:defRPr sz="1044" kern="1200">
          <a:solidFill>
            <a:schemeClr val="tx1"/>
          </a:solidFill>
          <a:latin typeface="+mn-lt"/>
          <a:ea typeface="+mn-ea"/>
          <a:cs typeface="+mn-cs"/>
        </a:defRPr>
      </a:lvl7pPr>
      <a:lvl8pPr marL="1988820" indent="-132588" algn="l" defTabSz="530352" rtl="0" eaLnBrk="1" latinLnBrk="0" hangingPunct="1">
        <a:lnSpc>
          <a:spcPct val="90000"/>
        </a:lnSpc>
        <a:spcBef>
          <a:spcPts val="290"/>
        </a:spcBef>
        <a:buFont typeface="Arial" panose="020B0604020202020204" pitchFamily="34" charset="0"/>
        <a:buChar char="•"/>
        <a:defRPr sz="1044" kern="1200">
          <a:solidFill>
            <a:schemeClr val="tx1"/>
          </a:solidFill>
          <a:latin typeface="+mn-lt"/>
          <a:ea typeface="+mn-ea"/>
          <a:cs typeface="+mn-cs"/>
        </a:defRPr>
      </a:lvl8pPr>
      <a:lvl9pPr marL="2253996" indent="-132588" algn="l" defTabSz="530352" rtl="0" eaLnBrk="1" latinLnBrk="0" hangingPunct="1">
        <a:lnSpc>
          <a:spcPct val="90000"/>
        </a:lnSpc>
        <a:spcBef>
          <a:spcPts val="290"/>
        </a:spcBef>
        <a:buFont typeface="Arial" panose="020B0604020202020204" pitchFamily="34" charset="0"/>
        <a:buChar char="•"/>
        <a:defRPr sz="1044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530352" rtl="0" eaLnBrk="1" latinLnBrk="0" hangingPunct="1">
        <a:defRPr sz="1044" kern="1200">
          <a:solidFill>
            <a:schemeClr val="tx1"/>
          </a:solidFill>
          <a:latin typeface="+mn-lt"/>
          <a:ea typeface="+mn-ea"/>
          <a:cs typeface="+mn-cs"/>
        </a:defRPr>
      </a:lvl1pPr>
      <a:lvl2pPr marL="265176" algn="l" defTabSz="530352" rtl="0" eaLnBrk="1" latinLnBrk="0" hangingPunct="1">
        <a:defRPr sz="1044" kern="1200">
          <a:solidFill>
            <a:schemeClr val="tx1"/>
          </a:solidFill>
          <a:latin typeface="+mn-lt"/>
          <a:ea typeface="+mn-ea"/>
          <a:cs typeface="+mn-cs"/>
        </a:defRPr>
      </a:lvl2pPr>
      <a:lvl3pPr marL="530352" algn="l" defTabSz="530352" rtl="0" eaLnBrk="1" latinLnBrk="0" hangingPunct="1">
        <a:defRPr sz="1044" kern="1200">
          <a:solidFill>
            <a:schemeClr val="tx1"/>
          </a:solidFill>
          <a:latin typeface="+mn-lt"/>
          <a:ea typeface="+mn-ea"/>
          <a:cs typeface="+mn-cs"/>
        </a:defRPr>
      </a:lvl3pPr>
      <a:lvl4pPr marL="795528" algn="l" defTabSz="530352" rtl="0" eaLnBrk="1" latinLnBrk="0" hangingPunct="1">
        <a:defRPr sz="1044" kern="1200">
          <a:solidFill>
            <a:schemeClr val="tx1"/>
          </a:solidFill>
          <a:latin typeface="+mn-lt"/>
          <a:ea typeface="+mn-ea"/>
          <a:cs typeface="+mn-cs"/>
        </a:defRPr>
      </a:lvl4pPr>
      <a:lvl5pPr marL="1060704" algn="l" defTabSz="530352" rtl="0" eaLnBrk="1" latinLnBrk="0" hangingPunct="1">
        <a:defRPr sz="1044" kern="1200">
          <a:solidFill>
            <a:schemeClr val="tx1"/>
          </a:solidFill>
          <a:latin typeface="+mn-lt"/>
          <a:ea typeface="+mn-ea"/>
          <a:cs typeface="+mn-cs"/>
        </a:defRPr>
      </a:lvl5pPr>
      <a:lvl6pPr marL="1325880" algn="l" defTabSz="530352" rtl="0" eaLnBrk="1" latinLnBrk="0" hangingPunct="1">
        <a:defRPr sz="1044" kern="1200">
          <a:solidFill>
            <a:schemeClr val="tx1"/>
          </a:solidFill>
          <a:latin typeface="+mn-lt"/>
          <a:ea typeface="+mn-ea"/>
          <a:cs typeface="+mn-cs"/>
        </a:defRPr>
      </a:lvl6pPr>
      <a:lvl7pPr marL="1591056" algn="l" defTabSz="530352" rtl="0" eaLnBrk="1" latinLnBrk="0" hangingPunct="1">
        <a:defRPr sz="1044" kern="1200">
          <a:solidFill>
            <a:schemeClr val="tx1"/>
          </a:solidFill>
          <a:latin typeface="+mn-lt"/>
          <a:ea typeface="+mn-ea"/>
          <a:cs typeface="+mn-cs"/>
        </a:defRPr>
      </a:lvl7pPr>
      <a:lvl8pPr marL="1856232" algn="l" defTabSz="530352" rtl="0" eaLnBrk="1" latinLnBrk="0" hangingPunct="1">
        <a:defRPr sz="1044" kern="1200">
          <a:solidFill>
            <a:schemeClr val="tx1"/>
          </a:solidFill>
          <a:latin typeface="+mn-lt"/>
          <a:ea typeface="+mn-ea"/>
          <a:cs typeface="+mn-cs"/>
        </a:defRPr>
      </a:lvl8pPr>
      <a:lvl9pPr marL="2121408" algn="l" defTabSz="530352" rtl="0" eaLnBrk="1" latinLnBrk="0" hangingPunct="1">
        <a:defRPr sz="1044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2DB0D29-8B57-807F-2EC1-99A92275430B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/>
              <a:t>Supplemental Figures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BA20829-CB6F-7DEB-3E88-6F25F29CD753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770263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map of different colored dots&#10;&#10;Description automatically generated">
            <a:extLst>
              <a:ext uri="{FF2B5EF4-FFF2-40B4-BE49-F238E27FC236}">
                <a16:creationId xmlns:a16="http://schemas.microsoft.com/office/drawing/2014/main" id="{11B16D6E-2713-4558-46ED-74F3A39ADF68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r="1351"/>
          <a:stretch/>
        </p:blipFill>
        <p:spPr>
          <a:xfrm>
            <a:off x="18826" y="341365"/>
            <a:ext cx="4926548" cy="3652603"/>
          </a:xfrm>
          <a:prstGeom prst="rect">
            <a:avLst/>
          </a:prstGeom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id="{E253233F-2BE4-E77E-8E7F-1910AD91BC8C}"/>
              </a:ext>
            </a:extLst>
          </p:cNvPr>
          <p:cNvSpPr txBox="1"/>
          <p:nvPr/>
        </p:nvSpPr>
        <p:spPr>
          <a:xfrm>
            <a:off x="2192716" y="3267488"/>
            <a:ext cx="108760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omatotropes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09EA0ACF-BD04-1B58-211B-BD64D083F060}"/>
              </a:ext>
            </a:extLst>
          </p:cNvPr>
          <p:cNvSpPr txBox="1"/>
          <p:nvPr/>
        </p:nvSpPr>
        <p:spPr>
          <a:xfrm>
            <a:off x="2363540" y="775002"/>
            <a:ext cx="88757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ox2+ </a:t>
            </a:r>
          </a:p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em cells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6F204B21-1421-499D-EA06-4F83B436A7CA}"/>
              </a:ext>
            </a:extLst>
          </p:cNvPr>
          <p:cNvSpPr txBox="1"/>
          <p:nvPr/>
        </p:nvSpPr>
        <p:spPr>
          <a:xfrm>
            <a:off x="1143334" y="3432113"/>
            <a:ext cx="111325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onadotropes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3CC87688-062B-8CD1-1AE2-74021173B9CE}"/>
              </a:ext>
            </a:extLst>
          </p:cNvPr>
          <p:cNvSpPr txBox="1"/>
          <p:nvPr/>
        </p:nvSpPr>
        <p:spPr>
          <a:xfrm>
            <a:off x="851597" y="2839929"/>
            <a:ext cx="9998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yrotropes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DCFCA528-1F71-1530-C33E-605722F85C82}"/>
              </a:ext>
            </a:extLst>
          </p:cNvPr>
          <p:cNvSpPr txBox="1"/>
          <p:nvPr/>
        </p:nvSpPr>
        <p:spPr>
          <a:xfrm>
            <a:off x="1298825" y="1880381"/>
            <a:ext cx="96898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actotropes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AC93A027-0828-9A0F-9693-27BB9E5A6AC3}"/>
              </a:ext>
            </a:extLst>
          </p:cNvPr>
          <p:cNvSpPr txBox="1"/>
          <p:nvPr/>
        </p:nvSpPr>
        <p:spPr>
          <a:xfrm>
            <a:off x="2770080" y="1578926"/>
            <a:ext cx="108920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rticotropes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74B56EB4-644B-0749-BED0-3F4DA4EA1B85}"/>
              </a:ext>
            </a:extLst>
          </p:cNvPr>
          <p:cNvSpPr txBox="1"/>
          <p:nvPr/>
        </p:nvSpPr>
        <p:spPr>
          <a:xfrm>
            <a:off x="2778095" y="2459398"/>
            <a:ext cx="108920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lanotropes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EBB2420C-323B-3213-53F8-D774C30EA6DD}"/>
              </a:ext>
            </a:extLst>
          </p:cNvPr>
          <p:cNvSpPr txBox="1"/>
          <p:nvPr/>
        </p:nvSpPr>
        <p:spPr>
          <a:xfrm>
            <a:off x="659567" y="4229100"/>
            <a:ext cx="3987384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l Figure 1. UMAP File  showing pituitary cell clusters from scRNA-seq study.</a:t>
            </a:r>
          </a:p>
        </p:txBody>
      </p:sp>
    </p:spTree>
    <p:extLst>
      <p:ext uri="{BB962C8B-B14F-4D97-AF65-F5344CB8AC3E}">
        <p14:creationId xmlns:p14="http://schemas.microsoft.com/office/powerpoint/2010/main" val="34115430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652</TotalTime>
  <Words>26</Words>
  <Application>Microsoft Office PowerPoint</Application>
  <PresentationFormat>Custom</PresentationFormat>
  <Paragraphs>10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ptos</vt:lpstr>
      <vt:lpstr>Aptos Display</vt:lpstr>
      <vt:lpstr>Arial</vt:lpstr>
      <vt:lpstr>Times New Roman</vt:lpstr>
      <vt:lpstr>Office Theme</vt:lpstr>
      <vt:lpstr>Supplemental Figures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Childs, Gwen V</dc:creator>
  <cp:lastModifiedBy>Gillian Attard</cp:lastModifiedBy>
  <cp:revision>8</cp:revision>
  <dcterms:created xsi:type="dcterms:W3CDTF">2024-08-02T19:20:41Z</dcterms:created>
  <dcterms:modified xsi:type="dcterms:W3CDTF">2025-07-11T15:00:3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8ca390d5-a4f3-448c-8368-24080179bc53_Enabled">
    <vt:lpwstr>true</vt:lpwstr>
  </property>
  <property fmtid="{D5CDD505-2E9C-101B-9397-08002B2CF9AE}" pid="3" name="MSIP_Label_8ca390d5-a4f3-448c-8368-24080179bc53_SetDate">
    <vt:lpwstr>2024-08-02T22:12:24Z</vt:lpwstr>
  </property>
  <property fmtid="{D5CDD505-2E9C-101B-9397-08002B2CF9AE}" pid="4" name="MSIP_Label_8ca390d5-a4f3-448c-8368-24080179bc53_Method">
    <vt:lpwstr>Standard</vt:lpwstr>
  </property>
  <property fmtid="{D5CDD505-2E9C-101B-9397-08002B2CF9AE}" pid="5" name="MSIP_Label_8ca390d5-a4f3-448c-8368-24080179bc53_Name">
    <vt:lpwstr>Low Risk</vt:lpwstr>
  </property>
  <property fmtid="{D5CDD505-2E9C-101B-9397-08002B2CF9AE}" pid="6" name="MSIP_Label_8ca390d5-a4f3-448c-8368-24080179bc53_SiteId">
    <vt:lpwstr>5b703aa0-061f-4ed9-beca-765a39ee1304</vt:lpwstr>
  </property>
  <property fmtid="{D5CDD505-2E9C-101B-9397-08002B2CF9AE}" pid="7" name="MSIP_Label_8ca390d5-a4f3-448c-8368-24080179bc53_ActionId">
    <vt:lpwstr>e6dda8ef-95c6-4ad8-be05-858e916d5e95</vt:lpwstr>
  </property>
  <property fmtid="{D5CDD505-2E9C-101B-9397-08002B2CF9AE}" pid="8" name="MSIP_Label_8ca390d5-a4f3-448c-8368-24080179bc53_ContentBits">
    <vt:lpwstr>0</vt:lpwstr>
  </property>
</Properties>
</file>